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53"/>
    <p:restoredTop sz="98188" autoAdjust="0"/>
  </p:normalViewPr>
  <p:slideViewPr>
    <p:cSldViewPr snapToGrid="0" snapToObjects="1">
      <p:cViewPr>
        <p:scale>
          <a:sx n="70" d="100"/>
          <a:sy n="70" d="100"/>
        </p:scale>
        <p:origin x="1962" y="12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E028F2-E0D5-A742-A488-C7ACD16AE68E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C141B7-3D2E-FE4C-8C11-DE89D02F4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9480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85583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978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73264"/>
            <a:ext cx="3357563" cy="122082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186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0013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070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3338690"/>
            <a:ext cx="2257425" cy="94428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3338690"/>
            <a:ext cx="2257425" cy="94428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3134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5376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494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1377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4254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150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4855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308134"/>
              </p:ext>
            </p:extLst>
          </p:nvPr>
        </p:nvGraphicFramePr>
        <p:xfrm>
          <a:off x="455967" y="814729"/>
          <a:ext cx="3627967" cy="416306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1557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7226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7846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1" u="none" strike="noStrike" dirty="0">
                          <a:effectLst/>
                        </a:rPr>
                        <a:t>Target Gen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1" u="none" strike="noStrike" dirty="0" err="1">
                          <a:effectLst/>
                        </a:rPr>
                        <a:t>TaqMan</a:t>
                      </a:r>
                      <a:r>
                        <a:rPr lang="en-US" sz="1200" b="1" u="none" strike="noStrike" dirty="0">
                          <a:effectLst/>
                        </a:rPr>
                        <a:t>® Assay 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8460"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en-US" sz="1200" i="1" u="none" strike="noStrike" dirty="0">
                          <a:effectLst/>
                        </a:rPr>
                        <a:t>p53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i="1" u="none" strike="noStrike" dirty="0">
                          <a:effectLst/>
                        </a:rPr>
                        <a:t>Hs01034249_m1 (Ex 10-11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84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i="1" u="none" strike="noStrike" dirty="0">
                          <a:effectLst/>
                        </a:rPr>
                        <a:t>Hs01034253_m1 (Ex 4-5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846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u="none" strike="noStrike" dirty="0">
                          <a:effectLst/>
                        </a:rPr>
                        <a:t>UBR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u="none" strike="noStrike" dirty="0">
                          <a:effectLst/>
                        </a:rPr>
                        <a:t>Hs00419575_m1 (Ex 23-24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846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u="none" strike="noStrike" dirty="0">
                          <a:effectLst/>
                        </a:rPr>
                        <a:t>SHANK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u="none" strike="noStrike">
                          <a:effectLst/>
                        </a:rPr>
                        <a:t>Hs01061105_m1 (Ex 21-22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7846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u="none" strike="noStrike" dirty="0">
                          <a:effectLst/>
                        </a:rPr>
                        <a:t>BS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u="none" strike="noStrike" dirty="0">
                          <a:effectLst/>
                        </a:rPr>
                        <a:t>Hs00185720_m1 (Ex 5-6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7846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u="none" strike="noStrike" dirty="0">
                          <a:effectLst/>
                        </a:rPr>
                        <a:t>β2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u="none" strike="noStrike">
                          <a:effectLst/>
                        </a:rPr>
                        <a:t>4326319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7846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u="none" strike="noStrike">
                          <a:effectLst/>
                        </a:rPr>
                        <a:t>GAPDH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u="none" strike="noStrike">
                          <a:effectLst/>
                        </a:rPr>
                        <a:t>4310884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7846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u="none" strike="noStrike" dirty="0">
                          <a:effectLst/>
                        </a:rPr>
                        <a:t>TB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u="none" strike="noStrike">
                          <a:effectLst/>
                        </a:rPr>
                        <a:t>4326322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7846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u="none" strike="noStrike">
                          <a:effectLst/>
                        </a:rPr>
                        <a:t>18S RN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u="none" strike="noStrike">
                          <a:effectLst/>
                        </a:rPr>
                        <a:t>4319413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7846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u="none" strike="noStrike">
                          <a:effectLst/>
                        </a:rPr>
                        <a:t>HPRT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u="none" strike="noStrike" dirty="0">
                          <a:effectLst/>
                        </a:rPr>
                        <a:t>Hs99999909_m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404635" y="458794"/>
            <a:ext cx="25101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Calibri"/>
                <a:cs typeface="Calibri"/>
              </a:rPr>
              <a:t>S5 Table. </a:t>
            </a:r>
            <a:r>
              <a:rPr lang="en-GB" sz="1200" b="1" dirty="0" err="1">
                <a:latin typeface="Calibri"/>
                <a:cs typeface="Calibri"/>
              </a:rPr>
              <a:t>TaqMan</a:t>
            </a:r>
            <a:r>
              <a:rPr lang="en-GB" sz="1200" b="1" dirty="0">
                <a:latin typeface="Calibri"/>
                <a:cs typeface="Calibri"/>
              </a:rPr>
              <a:t>® assays for </a:t>
            </a:r>
            <a:r>
              <a:rPr lang="en-GB" sz="1200" b="1" dirty="0" err="1">
                <a:latin typeface="Calibri"/>
                <a:cs typeface="Calibri"/>
              </a:rPr>
              <a:t>qPCRs</a:t>
            </a:r>
            <a:r>
              <a:rPr lang="en-GB" sz="1200" b="1" dirty="0">
                <a:latin typeface="Calibri"/>
                <a:cs typeface="Calibri"/>
              </a:rPr>
              <a:t>.</a:t>
            </a:r>
            <a:endParaRPr lang="en-US" sz="1200" dirty="0">
              <a:latin typeface="Calibri"/>
              <a:cs typeface="Calibri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97403" y="5038532"/>
            <a:ext cx="47809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Calibri"/>
                <a:cs typeface="Calibri"/>
              </a:rPr>
              <a:t>Details of </a:t>
            </a:r>
            <a:r>
              <a:rPr lang="en-GB" sz="1200" dirty="0" err="1">
                <a:latin typeface="Calibri"/>
                <a:cs typeface="Calibri"/>
              </a:rPr>
              <a:t>TaqMan</a:t>
            </a:r>
            <a:r>
              <a:rPr lang="en-GB" sz="1200" dirty="0">
                <a:latin typeface="Calibri"/>
                <a:cs typeface="Calibri"/>
              </a:rPr>
              <a:t>® assays used for qPCR analysis of transcript expression.</a:t>
            </a:r>
            <a:endParaRPr lang="en-US" sz="1200" dirty="0">
              <a:latin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5813937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8</TotalTime>
  <Words>79</Words>
  <Application>Microsoft Office PowerPoint</Application>
  <PresentationFormat>A4 Paper (210x297 mm)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Data fits into the story after Fig.4. but before Table 1</dc:title>
  <dc:creator>Katica Trenevska</dc:creator>
  <cp:lastModifiedBy>chn off32</cp:lastModifiedBy>
  <cp:revision>36</cp:revision>
  <dcterms:created xsi:type="dcterms:W3CDTF">2018-04-20T07:10:06Z</dcterms:created>
  <dcterms:modified xsi:type="dcterms:W3CDTF">2021-04-01T09:49:44Z</dcterms:modified>
</cp:coreProperties>
</file>